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52" d="100"/>
          <a:sy n="52" d="100"/>
        </p:scale>
        <p:origin x="221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66492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92741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559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73510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05582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39652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87357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46374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6737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42498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95108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CE2CD-758D-4329-8F1D-AA1E422F9633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DAC58-F369-4C15-A65C-42D54BE574D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43038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-2058226" y="796344"/>
            <a:ext cx="266804" cy="5334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32080" tIns="66040" rIns="132080" bIns="66040" numCol="1" anchor="ctr" anchorCtr="0" compatLnSpc="1">
            <a:prstTxWarp prst="textNoShape">
              <a:avLst/>
            </a:prstTxWarp>
            <a:spAutoFit/>
          </a:bodyPr>
          <a:lstStyle/>
          <a:p>
            <a:endParaRPr lang="pt-BR" sz="2600"/>
          </a:p>
        </p:txBody>
      </p:sp>
      <p:sp>
        <p:nvSpPr>
          <p:cNvPr id="6" name="Retângulo 5"/>
          <p:cNvSpPr/>
          <p:nvPr/>
        </p:nvSpPr>
        <p:spPr>
          <a:xfrm>
            <a:off x="0" y="5458809"/>
            <a:ext cx="6834226" cy="1154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 contents involved in nitrogen metabolism of 4-week-old plants from two ILs of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nelli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o a genetic background of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copersic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82) grown at 400 µmol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lorophyll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+ 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;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lorophyll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;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no acid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trat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presented as means ±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4). 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fferent letters accompany means that differ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genotypes (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&lt; 0.05) by the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ukey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es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W: Fresh weight.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m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67" y="572182"/>
            <a:ext cx="6818459" cy="46619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38158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9</TotalTime>
  <Words>93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iente</dc:creator>
  <cp:lastModifiedBy>Cliente</cp:lastModifiedBy>
  <cp:revision>20</cp:revision>
  <dcterms:created xsi:type="dcterms:W3CDTF">2019-04-29T12:01:04Z</dcterms:created>
  <dcterms:modified xsi:type="dcterms:W3CDTF">2020-05-01T01:19:29Z</dcterms:modified>
</cp:coreProperties>
</file>